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15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33409" y="7529410"/>
            <a:ext cx="3033437" cy="21255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1" b="1" dirty="0"/>
              <a:t>Figure </a:t>
            </a:r>
            <a:r>
              <a:rPr lang="en-US" sz="1101" b="1" dirty="0" smtClean="0"/>
              <a:t>S</a:t>
            </a:r>
            <a:r>
              <a:rPr lang="en-US" altLang="ja-JP" sz="1101" b="1" dirty="0" smtClean="0"/>
              <a:t>5</a:t>
            </a:r>
            <a:r>
              <a:rPr lang="en-US" sz="1101" b="1" dirty="0" smtClean="0"/>
              <a:t>. </a:t>
            </a:r>
            <a:r>
              <a:rPr lang="en-US" sz="1101" b="1" dirty="0"/>
              <a:t>Linkage Disequilibrium (LD) Decay in GWAS hits overlapping/flanking </a:t>
            </a:r>
            <a:r>
              <a:rPr lang="en-US" sz="1101" b="1" i="1" dirty="0" err="1"/>
              <a:t>Xa</a:t>
            </a:r>
            <a:r>
              <a:rPr lang="en-US" sz="1101" b="1" dirty="0"/>
              <a:t> regions. </a:t>
            </a:r>
            <a:r>
              <a:rPr lang="en-US" sz="1101" dirty="0"/>
              <a:t>LD (r</a:t>
            </a:r>
            <a:r>
              <a:rPr lang="en-US" sz="1101" baseline="30000" dirty="0"/>
              <a:t>2</a:t>
            </a:r>
            <a:r>
              <a:rPr lang="en-US" sz="1101" dirty="0"/>
              <a:t>) measure was based on Composite Haplotype Method (CHM). a.) SNPs flanking </a:t>
            </a:r>
            <a:r>
              <a:rPr lang="en-US" sz="1101" i="1" dirty="0"/>
              <a:t>Xa14</a:t>
            </a:r>
            <a:r>
              <a:rPr lang="en-US" sz="1101" dirty="0"/>
              <a:t> (</a:t>
            </a:r>
            <a:r>
              <a:rPr lang="en-US" sz="1101" dirty="0" err="1"/>
              <a:t>chr</a:t>
            </a:r>
            <a:r>
              <a:rPr lang="en-US" sz="1101" dirty="0"/>
              <a:t> 4: 31-32.9Mb). b.) SNPs flanking </a:t>
            </a:r>
            <a:r>
              <a:rPr lang="en-US" sz="1101" i="1" dirty="0"/>
              <a:t>xa5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5: 200-900kb).  c.) SNPs flanking </a:t>
            </a:r>
            <a:r>
              <a:rPr lang="en-US" sz="1101" i="1" dirty="0"/>
              <a:t>Xa7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6: 26-28.6Mb).  d.) SNPs flanking </a:t>
            </a:r>
            <a:r>
              <a:rPr lang="en-US" sz="1101" i="1" dirty="0"/>
              <a:t>xa13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8: 25-27.9Mb).  e.) SNPs flanking </a:t>
            </a:r>
            <a:r>
              <a:rPr lang="en-US" sz="1101" i="1" dirty="0"/>
              <a:t>Xa21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11: 20.5-22Mb).  f.) SNPs flanking </a:t>
            </a:r>
            <a:r>
              <a:rPr lang="en-US" sz="1101" i="1" dirty="0"/>
              <a:t>Xa4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11: 26.5-28.9Mb).  g.) SNPs flanking </a:t>
            </a:r>
            <a:r>
              <a:rPr lang="en-US" sz="1101" i="1" dirty="0"/>
              <a:t>xa25 </a:t>
            </a:r>
            <a:r>
              <a:rPr lang="en-US" sz="1101" dirty="0"/>
              <a:t>(</a:t>
            </a:r>
            <a:r>
              <a:rPr lang="en-US" sz="1101" dirty="0" err="1"/>
              <a:t>chr</a:t>
            </a:r>
            <a:r>
              <a:rPr lang="en-US" sz="1101" dirty="0"/>
              <a:t> 12: 13-17.6Mb).  </a:t>
            </a:r>
          </a:p>
          <a:p>
            <a:pPr algn="just"/>
            <a:endParaRPr lang="en-US" sz="1101" dirty="0"/>
          </a:p>
        </p:txBody>
      </p:sp>
      <p:grpSp>
        <p:nvGrpSpPr>
          <p:cNvPr id="4" name="Group 3"/>
          <p:cNvGrpSpPr/>
          <p:nvPr/>
        </p:nvGrpSpPr>
        <p:grpSpPr>
          <a:xfrm>
            <a:off x="384964" y="394828"/>
            <a:ext cx="5428918" cy="9419089"/>
            <a:chOff x="384964" y="394827"/>
            <a:chExt cx="5428918" cy="941909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72699" y="394827"/>
              <a:ext cx="2590093" cy="2430033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229370" y="394827"/>
              <a:ext cx="2584512" cy="2430033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89949" y="2706310"/>
              <a:ext cx="2612421" cy="2457337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230756" y="2722692"/>
              <a:ext cx="2567764" cy="2430033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507200" y="5045097"/>
              <a:ext cx="2567764" cy="2430033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297740" y="5050558"/>
              <a:ext cx="2500780" cy="242457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489949" y="7356580"/>
              <a:ext cx="2523108" cy="2457337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384964" y="524173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29862" y="2837901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2563" y="5162001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c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48912" y="7479751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d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222095" y="565154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e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234796" y="2889254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f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241146" y="5207004"/>
              <a:ext cx="7898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xmlns="" val="238421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114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39:42Z</dcterms:modified>
</cp:coreProperties>
</file>